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7"/>
  </p:notesMasterIdLst>
  <p:sldIdLst>
    <p:sldId id="304" r:id="rId2"/>
    <p:sldId id="307" r:id="rId3"/>
    <p:sldId id="303" r:id="rId4"/>
    <p:sldId id="309" r:id="rId5"/>
    <p:sldId id="308" r:id="rId6"/>
  </p:sldIdLst>
  <p:sldSz cx="12192000" cy="16256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uan Luis López Cánovas" initials="JLLC" lastIdx="7" clrIdx="0">
    <p:extLst>
      <p:ext uri="{19B8F6BF-5375-455C-9EA6-DF929625EA0E}">
        <p15:presenceInfo xmlns:p15="http://schemas.microsoft.com/office/powerpoint/2012/main" userId="Juan Luis López Cánovas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78FDA"/>
    <a:srgbClr val="BDBD57"/>
    <a:srgbClr val="82C182"/>
    <a:srgbClr val="F99F9A"/>
    <a:srgbClr val="ACDFA5"/>
    <a:srgbClr val="7281DC"/>
    <a:srgbClr val="DD837E"/>
    <a:srgbClr val="F3F4A5"/>
    <a:srgbClr val="8BAB88"/>
    <a:srgbClr val="ACF5F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CF1AB2-1976-4502-BF36-3FF5EA218861}" styleName="Estilo medio 4 - Énfasis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591" autoAdjust="0"/>
    <p:restoredTop sz="95853" autoAdjust="0"/>
  </p:normalViewPr>
  <p:slideViewPr>
    <p:cSldViewPr snapToGrid="0">
      <p:cViewPr>
        <p:scale>
          <a:sx n="171" d="100"/>
          <a:sy n="171" d="100"/>
        </p:scale>
        <p:origin x="144" y="-5848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C97FDF-C6E4-A741-B9D6-8D9FC3000FA0}" type="datetimeFigureOut">
              <a:rPr lang="es-ES" smtClean="0"/>
              <a:t>29/9/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3703638" y="857250"/>
            <a:ext cx="173672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B66111-C31B-F54E-A78C-DA195364827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286032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B66111-C31B-F54E-A78C-DA195364827E}" type="slidenum">
              <a:rPr lang="es-ES" smtClean="0"/>
              <a:t>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93577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B66111-C31B-F54E-A78C-DA195364827E}" type="slidenum">
              <a:rPr lang="es-ES" smtClean="0"/>
              <a:t>4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223055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9981C-22AC-4B64-9116-FFBACCE553E7}" type="datetimeFigureOut">
              <a:rPr lang="es-ES" smtClean="0"/>
              <a:t>29/9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0FE29-3FEF-4BBF-84D0-35F154E15E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525180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9981C-22AC-4B64-9116-FFBACCE553E7}" type="datetimeFigureOut">
              <a:rPr lang="es-ES" smtClean="0"/>
              <a:t>29/9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0FE29-3FEF-4BBF-84D0-35F154E15E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648520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9981C-22AC-4B64-9116-FFBACCE553E7}" type="datetimeFigureOut">
              <a:rPr lang="es-ES" smtClean="0"/>
              <a:t>29/9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0FE29-3FEF-4BBF-84D0-35F154E15E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152030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9981C-22AC-4B64-9116-FFBACCE553E7}" type="datetimeFigureOut">
              <a:rPr lang="es-ES" smtClean="0"/>
              <a:t>29/9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0FE29-3FEF-4BBF-84D0-35F154E15E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7329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9981C-22AC-4B64-9116-FFBACCE553E7}" type="datetimeFigureOut">
              <a:rPr lang="es-ES" smtClean="0"/>
              <a:t>29/9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0FE29-3FEF-4BBF-84D0-35F154E15E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84461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9981C-22AC-4B64-9116-FFBACCE553E7}" type="datetimeFigureOut">
              <a:rPr lang="es-ES" smtClean="0"/>
              <a:t>29/9/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0FE29-3FEF-4BBF-84D0-35F154E15E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29281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9981C-22AC-4B64-9116-FFBACCE553E7}" type="datetimeFigureOut">
              <a:rPr lang="es-ES" smtClean="0"/>
              <a:t>29/9/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0FE29-3FEF-4BBF-84D0-35F154E15E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32826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9981C-22AC-4B64-9116-FFBACCE553E7}" type="datetimeFigureOut">
              <a:rPr lang="es-ES" smtClean="0"/>
              <a:t>29/9/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0FE29-3FEF-4BBF-84D0-35F154E15E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952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9981C-22AC-4B64-9116-FFBACCE553E7}" type="datetimeFigureOut">
              <a:rPr lang="es-ES" smtClean="0"/>
              <a:t>29/9/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0FE29-3FEF-4BBF-84D0-35F154E15E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212839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9981C-22AC-4B64-9116-FFBACCE553E7}" type="datetimeFigureOut">
              <a:rPr lang="es-ES" smtClean="0"/>
              <a:t>29/9/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0FE29-3FEF-4BBF-84D0-35F154E15E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091681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B9981C-22AC-4B64-9116-FFBACCE553E7}" type="datetimeFigureOut">
              <a:rPr lang="es-ES" smtClean="0"/>
              <a:t>29/9/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0FE29-3FEF-4BBF-84D0-35F154E15E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27561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B9981C-22AC-4B64-9116-FFBACCE553E7}" type="datetimeFigureOut">
              <a:rPr lang="es-ES" smtClean="0"/>
              <a:t>29/9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10FE29-3FEF-4BBF-84D0-35F154E15E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54328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svg"/><Relationship Id="rId4" Type="http://schemas.openxmlformats.org/officeDocument/2006/relationships/image" Target="../media/image3.png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3" Type="http://schemas.openxmlformats.org/officeDocument/2006/relationships/image" Target="../media/image10.emf"/><Relationship Id="rId7" Type="http://schemas.openxmlformats.org/officeDocument/2006/relationships/image" Target="../media/image14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emf"/><Relationship Id="rId5" Type="http://schemas.openxmlformats.org/officeDocument/2006/relationships/image" Target="../media/image12.emf"/><Relationship Id="rId10" Type="http://schemas.openxmlformats.org/officeDocument/2006/relationships/image" Target="../media/image17.emf"/><Relationship Id="rId4" Type="http://schemas.openxmlformats.org/officeDocument/2006/relationships/image" Target="../media/image11.emf"/><Relationship Id="rId9" Type="http://schemas.openxmlformats.org/officeDocument/2006/relationships/image" Target="../media/image16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emf"/><Relationship Id="rId3" Type="http://schemas.openxmlformats.org/officeDocument/2006/relationships/image" Target="../media/image18.emf"/><Relationship Id="rId7" Type="http://schemas.openxmlformats.org/officeDocument/2006/relationships/image" Target="../media/image2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emf"/><Relationship Id="rId5" Type="http://schemas.openxmlformats.org/officeDocument/2006/relationships/image" Target="../media/image20.emf"/><Relationship Id="rId10" Type="http://schemas.openxmlformats.org/officeDocument/2006/relationships/image" Target="../media/image25.emf"/><Relationship Id="rId4" Type="http://schemas.openxmlformats.org/officeDocument/2006/relationships/image" Target="../media/image19.emf"/><Relationship Id="rId9" Type="http://schemas.openxmlformats.org/officeDocument/2006/relationships/image" Target="../media/image24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8.emf"/><Relationship Id="rId4" Type="http://schemas.openxmlformats.org/officeDocument/2006/relationships/image" Target="../media/image27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7" Type="http://schemas.openxmlformats.org/officeDocument/2006/relationships/image" Target="../media/image34.emf"/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emf"/><Relationship Id="rId5" Type="http://schemas.openxmlformats.org/officeDocument/2006/relationships/image" Target="../media/image32.emf"/><Relationship Id="rId4" Type="http://schemas.openxmlformats.org/officeDocument/2006/relationships/image" Target="../media/image3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5289DB52-ED0D-DD40-A187-CB1C350C02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3472" y="3940852"/>
            <a:ext cx="11417167" cy="8030287"/>
          </a:xfrm>
          <a:prstGeom prst="rect">
            <a:avLst/>
          </a:prstGeom>
        </p:spPr>
      </p:pic>
      <p:grpSp>
        <p:nvGrpSpPr>
          <p:cNvPr id="5" name="Grupo 4">
            <a:extLst>
              <a:ext uri="{FF2B5EF4-FFF2-40B4-BE49-F238E27FC236}">
                <a16:creationId xmlns:a16="http://schemas.microsoft.com/office/drawing/2014/main" id="{721F0302-B318-4737-136C-ACAE9B5F43EB}"/>
              </a:ext>
            </a:extLst>
          </p:cNvPr>
          <p:cNvGrpSpPr/>
          <p:nvPr/>
        </p:nvGrpSpPr>
        <p:grpSpPr>
          <a:xfrm>
            <a:off x="5683033" y="331995"/>
            <a:ext cx="5667291" cy="3495748"/>
            <a:chOff x="5570552" y="157942"/>
            <a:chExt cx="6205967" cy="3973910"/>
          </a:xfrm>
        </p:grpSpPr>
        <p:pic>
          <p:nvPicPr>
            <p:cNvPr id="4" name="Imagen 3" descr="Gráfico&#10;&#10;Descripción generada automáticamente">
              <a:extLst>
                <a:ext uri="{FF2B5EF4-FFF2-40B4-BE49-F238E27FC236}">
                  <a16:creationId xmlns:a16="http://schemas.microsoft.com/office/drawing/2014/main" id="{D3C6C69E-F5AD-8643-8DEF-538CEAF63D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29058"/>
            <a:stretch/>
          </p:blipFill>
          <p:spPr>
            <a:xfrm>
              <a:off x="5570552" y="157942"/>
              <a:ext cx="6205967" cy="3973910"/>
            </a:xfrm>
            <a:prstGeom prst="rect">
              <a:avLst/>
            </a:prstGeom>
          </p:spPr>
        </p:pic>
        <p:pic>
          <p:nvPicPr>
            <p:cNvPr id="9" name="Gráfico 8">
              <a:extLst>
                <a:ext uri="{FF2B5EF4-FFF2-40B4-BE49-F238E27FC236}">
                  <a16:creationId xmlns:a16="http://schemas.microsoft.com/office/drawing/2014/main" id="{FA6A276F-4448-F740-8D24-85183322D0A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6960704" y="599707"/>
              <a:ext cx="2750377" cy="883064"/>
            </a:xfrm>
            <a:prstGeom prst="rect">
              <a:avLst/>
            </a:prstGeom>
          </p:spPr>
        </p:pic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E75C6D54-DDA9-2340-B8AD-FD007AB5C467}"/>
                </a:ext>
              </a:extLst>
            </p:cNvPr>
            <p:cNvSpPr txBox="1"/>
            <p:nvPr/>
          </p:nvSpPr>
          <p:spPr>
            <a:xfrm>
              <a:off x="11145511" y="786549"/>
              <a:ext cx="315727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s-ES" sz="1200" dirty="0"/>
                <a:t>NTAT</a:t>
              </a:r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EC465278-C7BC-1348-86B8-87E974519A15}"/>
                </a:ext>
              </a:extLst>
            </p:cNvPr>
            <p:cNvSpPr txBox="1"/>
            <p:nvPr/>
          </p:nvSpPr>
          <p:spPr>
            <a:xfrm>
              <a:off x="11145511" y="948906"/>
              <a:ext cx="404021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s-ES" sz="1200" dirty="0"/>
                <a:t>Tumor</a:t>
              </a: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D8FF52E0-29A6-8542-9B20-A02F538CAA7B}"/>
                </a:ext>
              </a:extLst>
            </p:cNvPr>
            <p:cNvSpPr txBox="1"/>
            <p:nvPr/>
          </p:nvSpPr>
          <p:spPr>
            <a:xfrm>
              <a:off x="11145511" y="624191"/>
              <a:ext cx="550073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108000" bIns="0" rtlCol="0">
              <a:spAutoFit/>
            </a:bodyPr>
            <a:lstStyle/>
            <a:p>
              <a:r>
                <a:rPr lang="es-ES" sz="1200" dirty="0"/>
                <a:t>Overall</a:t>
              </a:r>
            </a:p>
          </p:txBody>
        </p:sp>
      </p:grpSp>
      <p:sp>
        <p:nvSpPr>
          <p:cNvPr id="15" name="CuadroTexto 14">
            <a:extLst>
              <a:ext uri="{FF2B5EF4-FFF2-40B4-BE49-F238E27FC236}">
                <a16:creationId xmlns:a16="http://schemas.microsoft.com/office/drawing/2014/main" id="{E2E3693E-4F0B-F14B-B5E9-8DECEFD8C0AA}"/>
              </a:ext>
            </a:extLst>
          </p:cNvPr>
          <p:cNvSpPr txBox="1"/>
          <p:nvPr/>
        </p:nvSpPr>
        <p:spPr>
          <a:xfrm>
            <a:off x="159386" y="468916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A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CEC9A937-EEB5-4749-9857-C41F81007372}"/>
              </a:ext>
            </a:extLst>
          </p:cNvPr>
          <p:cNvSpPr txBox="1"/>
          <p:nvPr/>
        </p:nvSpPr>
        <p:spPr>
          <a:xfrm>
            <a:off x="5325243" y="493629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B</a:t>
            </a:r>
          </a:p>
        </p:txBody>
      </p:sp>
      <p:pic>
        <p:nvPicPr>
          <p:cNvPr id="40" name="Picture 4" descr="PLSPairImage">
            <a:extLst>
              <a:ext uri="{FF2B5EF4-FFF2-40B4-BE49-F238E27FC236}">
                <a16:creationId xmlns:a16="http://schemas.microsoft.com/office/drawing/2014/main" id="{96C39B4C-46B8-1E47-8FE5-E344035EBF2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77" t="5260" r="4209" b="4087"/>
          <a:stretch/>
        </p:blipFill>
        <p:spPr bwMode="auto">
          <a:xfrm>
            <a:off x="1093056" y="367293"/>
            <a:ext cx="3518701" cy="34894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1" name="CuadroTexto 40">
            <a:extLst>
              <a:ext uri="{FF2B5EF4-FFF2-40B4-BE49-F238E27FC236}">
                <a16:creationId xmlns:a16="http://schemas.microsoft.com/office/drawing/2014/main" id="{6DE5C28D-27F3-7346-A2F5-7EA44F09070E}"/>
              </a:ext>
            </a:extLst>
          </p:cNvPr>
          <p:cNvSpPr txBox="1"/>
          <p:nvPr/>
        </p:nvSpPr>
        <p:spPr>
          <a:xfrm>
            <a:off x="159386" y="3714621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C</a:t>
            </a: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E1B83CE6-5DD9-B54E-B707-690F6C25FF6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5748" y="12002121"/>
            <a:ext cx="6220515" cy="2289894"/>
          </a:xfrm>
          <a:prstGeom prst="rect">
            <a:avLst/>
          </a:prstGeom>
        </p:spPr>
      </p:pic>
      <p:pic>
        <p:nvPicPr>
          <p:cNvPr id="17" name="Imagen 16">
            <a:extLst>
              <a:ext uri="{FF2B5EF4-FFF2-40B4-BE49-F238E27FC236}">
                <a16:creationId xmlns:a16="http://schemas.microsoft.com/office/drawing/2014/main" id="{5B58F1E6-68AC-8040-85EC-E1EA8342233C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147" r="56852" b="85981"/>
          <a:stretch/>
        </p:blipFill>
        <p:spPr>
          <a:xfrm>
            <a:off x="8809532" y="8564716"/>
            <a:ext cx="828305" cy="2104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Imagen 17">
            <a:extLst>
              <a:ext uri="{FF2B5EF4-FFF2-40B4-BE49-F238E27FC236}">
                <a16:creationId xmlns:a16="http://schemas.microsoft.com/office/drawing/2014/main" id="{E751E5AC-3C95-354C-B844-F1037DE9C61B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977" t="14004" r="37345" b="73665"/>
          <a:stretch/>
        </p:blipFill>
        <p:spPr>
          <a:xfrm>
            <a:off x="9703433" y="8558806"/>
            <a:ext cx="1671334" cy="2253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Imagen 18">
            <a:extLst>
              <a:ext uri="{FF2B5EF4-FFF2-40B4-BE49-F238E27FC236}">
                <a16:creationId xmlns:a16="http://schemas.microsoft.com/office/drawing/2014/main" id="{FC8DF981-E2FD-9B46-9C17-C12AB855E5E4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6936" t="26336" r="52101" b="58419"/>
          <a:stretch/>
        </p:blipFill>
        <p:spPr>
          <a:xfrm>
            <a:off x="8809532" y="8864142"/>
            <a:ext cx="848861" cy="20609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Imagen 19">
            <a:extLst>
              <a:ext uri="{FF2B5EF4-FFF2-40B4-BE49-F238E27FC236}">
                <a16:creationId xmlns:a16="http://schemas.microsoft.com/office/drawing/2014/main" id="{B8C30279-2372-B246-96DA-A5E56BFFAA2E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409" t="41299" r="34660" b="44121"/>
          <a:stretch/>
        </p:blipFill>
        <p:spPr>
          <a:xfrm>
            <a:off x="8809532" y="9219905"/>
            <a:ext cx="1676795" cy="27529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Imagen 20">
            <a:extLst>
              <a:ext uri="{FF2B5EF4-FFF2-40B4-BE49-F238E27FC236}">
                <a16:creationId xmlns:a16="http://schemas.microsoft.com/office/drawing/2014/main" id="{3CC85FB5-90BF-F048-9BAA-7490353B90E8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231" t="55529" r="56521" b="30207"/>
          <a:stretch/>
        </p:blipFill>
        <p:spPr>
          <a:xfrm>
            <a:off x="9755553" y="8865349"/>
            <a:ext cx="848861" cy="2179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Imagen 21">
            <a:extLst>
              <a:ext uri="{FF2B5EF4-FFF2-40B4-BE49-F238E27FC236}">
                <a16:creationId xmlns:a16="http://schemas.microsoft.com/office/drawing/2014/main" id="{CA81354E-1079-DC4F-8968-A1C57E0FE7EC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394" t="69537" r="22967" b="14997"/>
          <a:stretch/>
        </p:blipFill>
        <p:spPr>
          <a:xfrm>
            <a:off x="8809532" y="9620770"/>
            <a:ext cx="1452313" cy="2104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Imagen 22">
            <a:extLst>
              <a:ext uri="{FF2B5EF4-FFF2-40B4-BE49-F238E27FC236}">
                <a16:creationId xmlns:a16="http://schemas.microsoft.com/office/drawing/2014/main" id="{C7D1A873-483F-BC48-9482-EB1F4A119DFE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5059" t="85296" r="53462"/>
          <a:stretch/>
        </p:blipFill>
        <p:spPr>
          <a:xfrm>
            <a:off x="10573956" y="9215974"/>
            <a:ext cx="1121628" cy="2593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Imagen 23">
            <a:extLst>
              <a:ext uri="{FF2B5EF4-FFF2-40B4-BE49-F238E27FC236}">
                <a16:creationId xmlns:a16="http://schemas.microsoft.com/office/drawing/2014/main" id="{E21FF09F-AD10-6E46-AE32-A025919A1E32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r="6956"/>
          <a:stretch/>
        </p:blipFill>
        <p:spPr>
          <a:xfrm>
            <a:off x="5356290" y="8600893"/>
            <a:ext cx="2478405" cy="52649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CuadroTexto 24">
            <a:extLst>
              <a:ext uri="{FF2B5EF4-FFF2-40B4-BE49-F238E27FC236}">
                <a16:creationId xmlns:a16="http://schemas.microsoft.com/office/drawing/2014/main" id="{BA54F587-9BF1-BF42-9F57-3C1024617005}"/>
              </a:ext>
            </a:extLst>
          </p:cNvPr>
          <p:cNvSpPr txBox="1"/>
          <p:nvPr/>
        </p:nvSpPr>
        <p:spPr>
          <a:xfrm>
            <a:off x="142216" y="11945073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D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1D4C9E4B-ED13-AD75-8584-A9594769781D}"/>
              </a:ext>
            </a:extLst>
          </p:cNvPr>
          <p:cNvSpPr txBox="1"/>
          <p:nvPr/>
        </p:nvSpPr>
        <p:spPr>
          <a:xfrm>
            <a:off x="163502" y="3473"/>
            <a:ext cx="30382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 err="1"/>
              <a:t>Supplemental</a:t>
            </a:r>
            <a:r>
              <a:rPr lang="es-ES" sz="2400" b="1" dirty="0"/>
              <a:t> Figure 1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A7852390-014F-C0F5-C6BA-7401FE270A1B}"/>
              </a:ext>
            </a:extLst>
          </p:cNvPr>
          <p:cNvSpPr txBox="1"/>
          <p:nvPr/>
        </p:nvSpPr>
        <p:spPr>
          <a:xfrm>
            <a:off x="204746" y="14292015"/>
            <a:ext cx="11782508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1. Expression of spliceosome components and splicing factors in HCC has a high predictive value and is associated to genomic alteration and poorly clinical features. 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) PLSDA analysis of principal components in Retrospective-1 cohort by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taboanalyst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5.0 showed a high predictive potential. (B) Random Forest Classification in Retrospective-1 cohort by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taboanalyst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5.0. OOB error indicate the predictive value of the model. (C) Transcriptomic and genomic alteration landscape of TCGA cohort of all spliceosome components and splicing factors altered in Retorspective-1 cohort and clinical features. (D) Percentage of inclusion among the 5 elements (Top 5) with more discriminatory capacity in all the studied cohorts by VIP Score analysis. </a:t>
            </a:r>
            <a:endParaRPr lang="es-ES" sz="2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21562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Imagen 14">
            <a:extLst>
              <a:ext uri="{FF2B5EF4-FFF2-40B4-BE49-F238E27FC236}">
                <a16:creationId xmlns:a16="http://schemas.microsoft.com/office/drawing/2014/main" id="{0E9A1C3B-6CD2-E04F-BAFB-A8E25FA0ED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8469" y="3834568"/>
            <a:ext cx="4527702" cy="1325181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AB24EF1C-AEC4-3746-82F5-F3B0D94821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28863" y="3838995"/>
            <a:ext cx="7086385" cy="1277697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368AF2D6-DDBB-E64F-94C1-C2219574F2C2}"/>
              </a:ext>
            </a:extLst>
          </p:cNvPr>
          <p:cNvSpPr txBox="1"/>
          <p:nvPr/>
        </p:nvSpPr>
        <p:spPr>
          <a:xfrm>
            <a:off x="7844345" y="61159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s-ES" dirty="0"/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9C4C1BD5-FB8F-C549-967B-8F4C77F4F50C}"/>
              </a:ext>
            </a:extLst>
          </p:cNvPr>
          <p:cNvSpPr txBox="1"/>
          <p:nvPr/>
        </p:nvSpPr>
        <p:spPr>
          <a:xfrm>
            <a:off x="6545298" y="610970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B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421A33C7-36D6-6B43-BFA2-E44FBDFE2EE5}"/>
              </a:ext>
            </a:extLst>
          </p:cNvPr>
          <p:cNvSpPr txBox="1"/>
          <p:nvPr/>
        </p:nvSpPr>
        <p:spPr>
          <a:xfrm>
            <a:off x="154278" y="611593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A</a:t>
            </a:r>
          </a:p>
        </p:txBody>
      </p:sp>
      <p:pic>
        <p:nvPicPr>
          <p:cNvPr id="2" name="Imagen 1">
            <a:extLst>
              <a:ext uri="{FF2B5EF4-FFF2-40B4-BE49-F238E27FC236}">
                <a16:creationId xmlns:a16="http://schemas.microsoft.com/office/drawing/2014/main" id="{A70FB3F0-BEA5-BD4F-9653-AAA2AB45EE1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27007" y="615122"/>
            <a:ext cx="3403060" cy="3007948"/>
          </a:xfrm>
          <a:prstGeom prst="rect">
            <a:avLst/>
          </a:prstGeom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id="{AEC8A985-0708-3643-964D-6E45E096BB7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4433" y="601963"/>
            <a:ext cx="3388566" cy="3004955"/>
          </a:xfrm>
          <a:prstGeom prst="rect">
            <a:avLst/>
          </a:prstGeom>
        </p:spPr>
      </p:pic>
      <p:pic>
        <p:nvPicPr>
          <p:cNvPr id="13" name="Imagen 12">
            <a:extLst>
              <a:ext uri="{FF2B5EF4-FFF2-40B4-BE49-F238E27FC236}">
                <a16:creationId xmlns:a16="http://schemas.microsoft.com/office/drawing/2014/main" id="{A7124974-F304-744F-82E1-C29507FAE29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55991" y="5483813"/>
            <a:ext cx="2018927" cy="2142535"/>
          </a:xfrm>
          <a:prstGeom prst="rect">
            <a:avLst/>
          </a:prstGeom>
        </p:spPr>
      </p:pic>
      <p:sp>
        <p:nvSpPr>
          <p:cNvPr id="14" name="CuadroTexto 13">
            <a:extLst>
              <a:ext uri="{FF2B5EF4-FFF2-40B4-BE49-F238E27FC236}">
                <a16:creationId xmlns:a16="http://schemas.microsoft.com/office/drawing/2014/main" id="{9A3BC266-18FD-D24C-A886-1A04AE3B774E}"/>
              </a:ext>
            </a:extLst>
          </p:cNvPr>
          <p:cNvSpPr txBox="1"/>
          <p:nvPr/>
        </p:nvSpPr>
        <p:spPr>
          <a:xfrm>
            <a:off x="151547" y="5105952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E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018E0559-19F8-3F41-B9F3-512B8B1B17F5}"/>
              </a:ext>
            </a:extLst>
          </p:cNvPr>
          <p:cNvSpPr txBox="1"/>
          <p:nvPr/>
        </p:nvSpPr>
        <p:spPr>
          <a:xfrm>
            <a:off x="2431305" y="5104800"/>
            <a:ext cx="3257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F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F39B3877-08E8-8544-A58F-C8C6C579D5F7}"/>
              </a:ext>
            </a:extLst>
          </p:cNvPr>
          <p:cNvSpPr txBox="1"/>
          <p:nvPr/>
        </p:nvSpPr>
        <p:spPr>
          <a:xfrm>
            <a:off x="4726101" y="5104800"/>
            <a:ext cx="3802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G</a:t>
            </a:r>
          </a:p>
        </p:txBody>
      </p:sp>
      <p:pic>
        <p:nvPicPr>
          <p:cNvPr id="21" name="Imagen 20">
            <a:extLst>
              <a:ext uri="{FF2B5EF4-FFF2-40B4-BE49-F238E27FC236}">
                <a16:creationId xmlns:a16="http://schemas.microsoft.com/office/drawing/2014/main" id="{935E445C-88F6-264E-977F-513DF366F3A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8638" y="5489690"/>
            <a:ext cx="1991887" cy="2142534"/>
          </a:xfrm>
          <a:prstGeom prst="rect">
            <a:avLst/>
          </a:prstGeom>
        </p:spPr>
      </p:pic>
      <p:sp>
        <p:nvSpPr>
          <p:cNvPr id="24" name="CuadroTexto 23">
            <a:extLst>
              <a:ext uri="{FF2B5EF4-FFF2-40B4-BE49-F238E27FC236}">
                <a16:creationId xmlns:a16="http://schemas.microsoft.com/office/drawing/2014/main" id="{A4853638-0E02-544A-AA05-FDB27B1AAFDD}"/>
              </a:ext>
            </a:extLst>
          </p:cNvPr>
          <p:cNvSpPr txBox="1"/>
          <p:nvPr/>
        </p:nvSpPr>
        <p:spPr>
          <a:xfrm>
            <a:off x="152320" y="3726554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C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0C5E4163-912B-2745-A4BC-D4B243AF859C}"/>
              </a:ext>
            </a:extLst>
          </p:cNvPr>
          <p:cNvSpPr txBox="1"/>
          <p:nvPr/>
        </p:nvSpPr>
        <p:spPr>
          <a:xfrm>
            <a:off x="4712337" y="3697468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D</a:t>
            </a:r>
          </a:p>
        </p:txBody>
      </p:sp>
      <p:sp>
        <p:nvSpPr>
          <p:cNvPr id="10" name="Rectángulo 9">
            <a:extLst>
              <a:ext uri="{FF2B5EF4-FFF2-40B4-BE49-F238E27FC236}">
                <a16:creationId xmlns:a16="http://schemas.microsoft.com/office/drawing/2014/main" id="{BFDB3848-6931-BC41-96B1-49A7E52BA0F4}"/>
              </a:ext>
            </a:extLst>
          </p:cNvPr>
          <p:cNvSpPr/>
          <p:nvPr/>
        </p:nvSpPr>
        <p:spPr>
          <a:xfrm>
            <a:off x="4941647" y="5528015"/>
            <a:ext cx="177470" cy="1076575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s-ES" sz="1100" dirty="0">
                <a:solidFill>
                  <a:sysClr val="windowText" lastClr="000000"/>
                </a:solidFill>
              </a:rPr>
              <a:t>Retrospective-1</a:t>
            </a:r>
          </a:p>
        </p:txBody>
      </p:sp>
      <p:pic>
        <p:nvPicPr>
          <p:cNvPr id="11" name="Imagen 10">
            <a:extLst>
              <a:ext uri="{FF2B5EF4-FFF2-40B4-BE49-F238E27FC236}">
                <a16:creationId xmlns:a16="http://schemas.microsoft.com/office/drawing/2014/main" id="{F6691D39-3E87-EF45-B93C-A418D7B5D50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724103" y="841802"/>
            <a:ext cx="1628174" cy="1812496"/>
          </a:xfrm>
          <a:prstGeom prst="rect">
            <a:avLst/>
          </a:prstGeom>
        </p:spPr>
      </p:pic>
      <p:sp>
        <p:nvSpPr>
          <p:cNvPr id="26" name="Rectángulo 25">
            <a:extLst>
              <a:ext uri="{FF2B5EF4-FFF2-40B4-BE49-F238E27FC236}">
                <a16:creationId xmlns:a16="http://schemas.microsoft.com/office/drawing/2014/main" id="{CDE6EAB8-7EEE-5C4A-A97E-90F9C51E1F37}"/>
              </a:ext>
            </a:extLst>
          </p:cNvPr>
          <p:cNvSpPr/>
          <p:nvPr/>
        </p:nvSpPr>
        <p:spPr>
          <a:xfrm>
            <a:off x="4928863" y="6758183"/>
            <a:ext cx="177470" cy="1076575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s-ES" sz="1100" dirty="0">
                <a:solidFill>
                  <a:sysClr val="windowText" lastClr="000000"/>
                </a:solidFill>
              </a:rPr>
              <a:t>Retrospective-2</a:t>
            </a:r>
          </a:p>
        </p:txBody>
      </p:sp>
      <p:pic>
        <p:nvPicPr>
          <p:cNvPr id="17" name="Imagen 16">
            <a:extLst>
              <a:ext uri="{FF2B5EF4-FFF2-40B4-BE49-F238E27FC236}">
                <a16:creationId xmlns:a16="http://schemas.microsoft.com/office/drawing/2014/main" id="{214F3E7E-AA65-9A45-92F0-53B5F2BB4F3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106333" y="5418769"/>
            <a:ext cx="5715177" cy="1295065"/>
          </a:xfrm>
          <a:prstGeom prst="rect">
            <a:avLst/>
          </a:prstGeom>
        </p:spPr>
      </p:pic>
      <p:pic>
        <p:nvPicPr>
          <p:cNvPr id="18" name="Imagen 17">
            <a:extLst>
              <a:ext uri="{FF2B5EF4-FFF2-40B4-BE49-F238E27FC236}">
                <a16:creationId xmlns:a16="http://schemas.microsoft.com/office/drawing/2014/main" id="{93AB7044-72A9-2540-A790-C71CC758139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106333" y="6649266"/>
            <a:ext cx="4489463" cy="1294407"/>
          </a:xfrm>
          <a:prstGeom prst="rect">
            <a:avLst/>
          </a:prstGeom>
        </p:spPr>
      </p:pic>
      <p:sp>
        <p:nvSpPr>
          <p:cNvPr id="27" name="CuadroTexto 26">
            <a:extLst>
              <a:ext uri="{FF2B5EF4-FFF2-40B4-BE49-F238E27FC236}">
                <a16:creationId xmlns:a16="http://schemas.microsoft.com/office/drawing/2014/main" id="{4BE87BA8-C661-78A6-D549-195940A778FC}"/>
              </a:ext>
            </a:extLst>
          </p:cNvPr>
          <p:cNvSpPr txBox="1"/>
          <p:nvPr/>
        </p:nvSpPr>
        <p:spPr>
          <a:xfrm>
            <a:off x="163502" y="3473"/>
            <a:ext cx="30382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 err="1"/>
              <a:t>Supplemental</a:t>
            </a:r>
            <a:r>
              <a:rPr lang="es-ES" sz="2400" b="1" dirty="0"/>
              <a:t> Figure 2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27F5013E-9BC5-301F-7885-9A6890C07F45}"/>
              </a:ext>
            </a:extLst>
          </p:cNvPr>
          <p:cNvSpPr txBox="1"/>
          <p:nvPr/>
        </p:nvSpPr>
        <p:spPr>
          <a:xfrm>
            <a:off x="408469" y="8128000"/>
            <a:ext cx="11491983" cy="31393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2. Spliceosome components and splicing factors are associated to clinical aggressiveness and poor survival of HCC patients. 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) Overall survival of patients from Retrospective-1 cohort categorized by the mRNA expression levels </a:t>
            </a:r>
            <a:r>
              <a:rPr lang="en-GB" sz="18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f SRPK1 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nd RBM3 [patients with highest expression vs. lowest expression group (cut-of=median)] determined by long-rank-p-value method. (B) Association between RBM3 expression and microvascular invasion in Retrospective-1 cohort. (C) Correlation between ESRP2 expression and the expression of oncogenic splicing variant in HCC in Retrospective-1 cohort. (D) Correlation between SRPK1 expression and the expression of oncogenic splicing variant in HCC in Retrospective-1 cohort. (E) Expression of EIF4A3 in HCC samples from patients with different aetiologies in Retrospective-1 cohort. (F) Expression of EIF4A3 in HCC samples from patients with different aetiologies in Retrospective-2 cohort. (G) Correlation between EIF4A3 expression and the expression of oncogenic splicing variant in HCC in Retrospective-1 and Retrospective-2 cohorts.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e asterisks (* p&lt;0,05; ** p&lt;0,01; **** p&lt;0,0001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indicate statistically significant differences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HR means hazard ratio.</a:t>
            </a:r>
            <a:endParaRPr lang="es-ES" sz="2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98279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Imagen 36">
            <a:extLst>
              <a:ext uri="{FF2B5EF4-FFF2-40B4-BE49-F238E27FC236}">
                <a16:creationId xmlns:a16="http://schemas.microsoft.com/office/drawing/2014/main" id="{75E37DC5-BF21-82BA-B0D5-5481F6B965D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20211" y="596437"/>
            <a:ext cx="4138935" cy="2876480"/>
          </a:xfrm>
          <a:prstGeom prst="rect">
            <a:avLst/>
          </a:prstGeom>
        </p:spPr>
      </p:pic>
      <p:pic>
        <p:nvPicPr>
          <p:cNvPr id="33" name="Imagen 32">
            <a:extLst>
              <a:ext uri="{FF2B5EF4-FFF2-40B4-BE49-F238E27FC236}">
                <a16:creationId xmlns:a16="http://schemas.microsoft.com/office/drawing/2014/main" id="{2C1834F0-BCFE-914A-B765-C707F31C416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0182" t="44797" b="41199"/>
          <a:stretch/>
        </p:blipFill>
        <p:spPr>
          <a:xfrm>
            <a:off x="2875470" y="3562753"/>
            <a:ext cx="1270257" cy="338638"/>
          </a:xfrm>
          <a:prstGeom prst="rect">
            <a:avLst/>
          </a:prstGeom>
        </p:spPr>
      </p:pic>
      <p:pic>
        <p:nvPicPr>
          <p:cNvPr id="13" name="Imagen 12">
            <a:extLst>
              <a:ext uri="{FF2B5EF4-FFF2-40B4-BE49-F238E27FC236}">
                <a16:creationId xmlns:a16="http://schemas.microsoft.com/office/drawing/2014/main" id="{879D957A-F753-CB46-BDA5-05F4521D29C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4847" y="693849"/>
            <a:ext cx="2381654" cy="1920689"/>
          </a:xfrm>
          <a:prstGeom prst="rect">
            <a:avLst/>
          </a:prstGeom>
        </p:spPr>
      </p:pic>
      <p:sp>
        <p:nvSpPr>
          <p:cNvPr id="15" name="CuadroTexto 14">
            <a:extLst>
              <a:ext uri="{FF2B5EF4-FFF2-40B4-BE49-F238E27FC236}">
                <a16:creationId xmlns:a16="http://schemas.microsoft.com/office/drawing/2014/main" id="{B32A1B3F-D990-7043-B685-C17F80D6AB3D}"/>
              </a:ext>
            </a:extLst>
          </p:cNvPr>
          <p:cNvSpPr txBox="1"/>
          <p:nvPr/>
        </p:nvSpPr>
        <p:spPr>
          <a:xfrm>
            <a:off x="84642" y="3848269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D</a:t>
            </a:r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B484C50E-2A6F-4A4E-8556-83E2DD02B97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7471" y="4049102"/>
            <a:ext cx="2184400" cy="2298700"/>
          </a:xfrm>
          <a:prstGeom prst="rect">
            <a:avLst/>
          </a:prstGeom>
        </p:spPr>
      </p:pic>
      <p:pic>
        <p:nvPicPr>
          <p:cNvPr id="16" name="Imagen 15">
            <a:extLst>
              <a:ext uri="{FF2B5EF4-FFF2-40B4-BE49-F238E27FC236}">
                <a16:creationId xmlns:a16="http://schemas.microsoft.com/office/drawing/2014/main" id="{687B21F1-BCAB-A142-8FB1-BDFE793BC4A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39747" y="4334674"/>
            <a:ext cx="9411500" cy="1765138"/>
          </a:xfrm>
          <a:prstGeom prst="rect">
            <a:avLst/>
          </a:prstGeom>
        </p:spPr>
      </p:pic>
      <p:sp>
        <p:nvSpPr>
          <p:cNvPr id="17" name="CuadroTexto 16">
            <a:extLst>
              <a:ext uri="{FF2B5EF4-FFF2-40B4-BE49-F238E27FC236}">
                <a16:creationId xmlns:a16="http://schemas.microsoft.com/office/drawing/2014/main" id="{806E055E-D979-4A4B-9247-ADE67AE7CA0C}"/>
              </a:ext>
            </a:extLst>
          </p:cNvPr>
          <p:cNvSpPr txBox="1"/>
          <p:nvPr/>
        </p:nvSpPr>
        <p:spPr>
          <a:xfrm>
            <a:off x="9013596" y="3864436"/>
            <a:ext cx="1008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SNU-387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20F60292-95D5-3244-81D3-7E3318D028F1}"/>
              </a:ext>
            </a:extLst>
          </p:cNvPr>
          <p:cNvSpPr txBox="1"/>
          <p:nvPr/>
        </p:nvSpPr>
        <p:spPr>
          <a:xfrm>
            <a:off x="8015040" y="4091663"/>
            <a:ext cx="8699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/>
              <a:t>Scramble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AC5F3916-4A01-8E43-A2C4-008EDA68EE67}"/>
              </a:ext>
            </a:extLst>
          </p:cNvPr>
          <p:cNvSpPr txBox="1"/>
          <p:nvPr/>
        </p:nvSpPr>
        <p:spPr>
          <a:xfrm>
            <a:off x="10420997" y="4091663"/>
            <a:ext cx="10326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iEIF4A3 #1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0B831E25-43B3-2F49-BA90-EEF2F1DC3949}"/>
              </a:ext>
            </a:extLst>
          </p:cNvPr>
          <p:cNvSpPr txBox="1"/>
          <p:nvPr/>
        </p:nvSpPr>
        <p:spPr>
          <a:xfrm>
            <a:off x="4239796" y="3851280"/>
            <a:ext cx="816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Hep3B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382CA381-65D6-924C-9FDF-ED635ADDCFD6}"/>
              </a:ext>
            </a:extLst>
          </p:cNvPr>
          <p:cNvSpPr txBox="1"/>
          <p:nvPr/>
        </p:nvSpPr>
        <p:spPr>
          <a:xfrm>
            <a:off x="3241240" y="4078507"/>
            <a:ext cx="8699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/>
              <a:t>Scramble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69B20F41-746A-4D4A-980E-FD4BD6EFB7FA}"/>
              </a:ext>
            </a:extLst>
          </p:cNvPr>
          <p:cNvSpPr txBox="1"/>
          <p:nvPr/>
        </p:nvSpPr>
        <p:spPr>
          <a:xfrm>
            <a:off x="5647197" y="4078507"/>
            <a:ext cx="10326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iEIF4A3 #1</a:t>
            </a:r>
          </a:p>
        </p:txBody>
      </p:sp>
      <p:pic>
        <p:nvPicPr>
          <p:cNvPr id="28" name="Imagen 27">
            <a:extLst>
              <a:ext uri="{FF2B5EF4-FFF2-40B4-BE49-F238E27FC236}">
                <a16:creationId xmlns:a16="http://schemas.microsoft.com/office/drawing/2014/main" id="{A0AB3A35-4A1D-E447-97C3-B0729080680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0182" t="56840" b="31489"/>
          <a:stretch/>
        </p:blipFill>
        <p:spPr>
          <a:xfrm>
            <a:off x="4026489" y="3564109"/>
            <a:ext cx="1270258" cy="282199"/>
          </a:xfrm>
          <a:prstGeom prst="rect">
            <a:avLst/>
          </a:prstGeom>
        </p:spPr>
      </p:pic>
      <p:pic>
        <p:nvPicPr>
          <p:cNvPr id="29" name="Imagen 28">
            <a:extLst>
              <a:ext uri="{FF2B5EF4-FFF2-40B4-BE49-F238E27FC236}">
                <a16:creationId xmlns:a16="http://schemas.microsoft.com/office/drawing/2014/main" id="{3EB68678-5FD9-B14E-A450-4325C6599D1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0182" t="67735" b="18261"/>
          <a:stretch/>
        </p:blipFill>
        <p:spPr>
          <a:xfrm>
            <a:off x="5244183" y="3551041"/>
            <a:ext cx="1270257" cy="338638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id="{DE529A23-7506-FD42-8D49-BC912F7A1721}"/>
              </a:ext>
            </a:extLst>
          </p:cNvPr>
          <p:cNvSpPr txBox="1"/>
          <p:nvPr/>
        </p:nvSpPr>
        <p:spPr>
          <a:xfrm>
            <a:off x="80804" y="524492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A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F26AEACE-AFA5-6942-AA03-F6FE6BD8DD15}"/>
              </a:ext>
            </a:extLst>
          </p:cNvPr>
          <p:cNvSpPr txBox="1"/>
          <p:nvPr/>
        </p:nvSpPr>
        <p:spPr>
          <a:xfrm>
            <a:off x="54329" y="6140548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E</a:t>
            </a:r>
          </a:p>
        </p:txBody>
      </p:sp>
      <p:pic>
        <p:nvPicPr>
          <p:cNvPr id="5" name="Imagen 4">
            <a:extLst>
              <a:ext uri="{FF2B5EF4-FFF2-40B4-BE49-F238E27FC236}">
                <a16:creationId xmlns:a16="http://schemas.microsoft.com/office/drawing/2014/main" id="{FA98F232-7C36-64CF-162B-E25EEE9B5B9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096000" y="524492"/>
            <a:ext cx="6015196" cy="2208360"/>
          </a:xfrm>
          <a:prstGeom prst="rect">
            <a:avLst/>
          </a:prstGeom>
        </p:spPr>
      </p:pic>
      <p:sp>
        <p:nvSpPr>
          <p:cNvPr id="9" name="CuadroTexto 8">
            <a:extLst>
              <a:ext uri="{FF2B5EF4-FFF2-40B4-BE49-F238E27FC236}">
                <a16:creationId xmlns:a16="http://schemas.microsoft.com/office/drawing/2014/main" id="{FFEC9C51-128B-E642-861A-2034E5145D8C}"/>
              </a:ext>
            </a:extLst>
          </p:cNvPr>
          <p:cNvSpPr txBox="1"/>
          <p:nvPr/>
        </p:nvSpPr>
        <p:spPr>
          <a:xfrm>
            <a:off x="2787966" y="524492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B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02A3DCE6-4756-664E-8463-44E0030356B3}"/>
              </a:ext>
            </a:extLst>
          </p:cNvPr>
          <p:cNvSpPr txBox="1"/>
          <p:nvPr/>
        </p:nvSpPr>
        <p:spPr>
          <a:xfrm>
            <a:off x="5903819" y="524492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C</a:t>
            </a:r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AE15DEE9-3688-9302-5FE8-F019382ED55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61023" y="6414541"/>
            <a:ext cx="2384956" cy="2268932"/>
          </a:xfrm>
          <a:prstGeom prst="rect">
            <a:avLst/>
          </a:prstGeom>
        </p:spPr>
      </p:pic>
      <p:pic>
        <p:nvPicPr>
          <p:cNvPr id="34" name="Imagen 33">
            <a:extLst>
              <a:ext uri="{FF2B5EF4-FFF2-40B4-BE49-F238E27FC236}">
                <a16:creationId xmlns:a16="http://schemas.microsoft.com/office/drawing/2014/main" id="{03FE681A-745D-46EC-0B73-BE51C003CB6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331441" y="6336449"/>
            <a:ext cx="4265590" cy="2268931"/>
          </a:xfrm>
          <a:prstGeom prst="rect">
            <a:avLst/>
          </a:prstGeom>
        </p:spPr>
      </p:pic>
      <p:sp>
        <p:nvSpPr>
          <p:cNvPr id="36" name="CuadroTexto 35">
            <a:extLst>
              <a:ext uri="{FF2B5EF4-FFF2-40B4-BE49-F238E27FC236}">
                <a16:creationId xmlns:a16="http://schemas.microsoft.com/office/drawing/2014/main" id="{DAB76339-E49E-6089-832A-B4F6FD8161B7}"/>
              </a:ext>
            </a:extLst>
          </p:cNvPr>
          <p:cNvSpPr txBox="1"/>
          <p:nvPr/>
        </p:nvSpPr>
        <p:spPr>
          <a:xfrm>
            <a:off x="3033657" y="6140548"/>
            <a:ext cx="3257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F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9BDF8170-F31A-2F2A-7131-73219EC22D8E}"/>
              </a:ext>
            </a:extLst>
          </p:cNvPr>
          <p:cNvSpPr txBox="1"/>
          <p:nvPr/>
        </p:nvSpPr>
        <p:spPr>
          <a:xfrm>
            <a:off x="163502" y="3473"/>
            <a:ext cx="30382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 err="1"/>
              <a:t>Supplemental</a:t>
            </a:r>
            <a:r>
              <a:rPr lang="es-ES" sz="2400" b="1" dirty="0"/>
              <a:t> Figure 3</a:t>
            </a: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11F03011-E481-D4E1-8330-C1F402DB6B82}"/>
              </a:ext>
            </a:extLst>
          </p:cNvPr>
          <p:cNvSpPr txBox="1"/>
          <p:nvPr/>
        </p:nvSpPr>
        <p:spPr>
          <a:xfrm>
            <a:off x="389677" y="8998202"/>
            <a:ext cx="11461570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3. EIF4A3 silencing and overexpression validation, and functional assays. 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) Validation of EIF4A3 expression in siEIF4A3-treated cells compared to scramble-treated HepG2, Hep3B and SNU-387 cells at mRNA level by qPCR. (B) Validation of EIF4A3 expression in siEIF4A3-treated HepG2, Hep3B and SNU-387 cells compared to scramble-treated cells at protein level by western-blot. (C) siEIF4A3 dose-dependent (5nM, 15nM and 25nM) cell proliferation at 24h, 48h and 72h in HepG2, Hep3B and SNU-387 cell lines. (D) Invasion assay in siEIF4A3-treated Hep3B and SNU-387 cells compared to scramble-treated cells at 24h. Representative images of invasive cells after 24 days are depicted. (E) Validation of EIF4A3 expression in pEIF4A3-transfected Hep3B cells compared to mock-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rasfected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ells at mRNA level by qPCR. (F) Validation of EIF4A3 expression in pEIF4A3-transfected Hep3B cells compared to mock-transfected cells at protein level by western-blot. Data are presented as mean ± SEM from n=3-5 independent experiments.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terisks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* p&lt;0,05; ** p&lt;0,01; *** p&lt;0,001; **** p&lt;0,0001)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indicate statistically significant differences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es-ES" sz="2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16905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1B87F4EA-5B38-0835-3001-999C4F1DA1A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68724" y="726530"/>
            <a:ext cx="6228290" cy="4824385"/>
          </a:xfrm>
          <a:prstGeom prst="rect">
            <a:avLst/>
          </a:prstGeom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DA069E03-CBBA-6B88-F6C7-AE492EB4C44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96726" y="5904530"/>
            <a:ext cx="4787192" cy="1519411"/>
          </a:xfrm>
          <a:prstGeom prst="rect">
            <a:avLst/>
          </a:prstGeom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id="{CDB1A6CE-FBE9-A026-0CDB-010DD85B779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4782" y="708181"/>
            <a:ext cx="4902200" cy="6654800"/>
          </a:xfrm>
          <a:prstGeom prst="rect">
            <a:avLst/>
          </a:prstGeom>
        </p:spPr>
      </p:pic>
      <p:pic>
        <p:nvPicPr>
          <p:cNvPr id="9" name="Imagen 8">
            <a:extLst>
              <a:ext uri="{FF2B5EF4-FFF2-40B4-BE49-F238E27FC236}">
                <a16:creationId xmlns:a16="http://schemas.microsoft.com/office/drawing/2014/main" id="{9AB1902F-0782-BB75-0F76-070278E66D8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2603" t="84178"/>
          <a:stretch/>
        </p:blipFill>
        <p:spPr>
          <a:xfrm>
            <a:off x="4163164" y="6073254"/>
            <a:ext cx="1248122" cy="558308"/>
          </a:xfrm>
          <a:prstGeom prst="rect">
            <a:avLst/>
          </a:prstGeom>
        </p:spPr>
      </p:pic>
      <p:sp>
        <p:nvSpPr>
          <p:cNvPr id="10" name="CuadroTexto 9">
            <a:extLst>
              <a:ext uri="{FF2B5EF4-FFF2-40B4-BE49-F238E27FC236}">
                <a16:creationId xmlns:a16="http://schemas.microsoft.com/office/drawing/2014/main" id="{F083456B-9B59-2AA9-48FC-445F55B46125}"/>
              </a:ext>
            </a:extLst>
          </p:cNvPr>
          <p:cNvSpPr txBox="1"/>
          <p:nvPr/>
        </p:nvSpPr>
        <p:spPr>
          <a:xfrm>
            <a:off x="624782" y="495699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A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10BA86C6-FD8C-4B90-9F7B-A20938B32FE8}"/>
              </a:ext>
            </a:extLst>
          </p:cNvPr>
          <p:cNvSpPr txBox="1"/>
          <p:nvPr/>
        </p:nvSpPr>
        <p:spPr>
          <a:xfrm>
            <a:off x="5399896" y="495698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B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DC692972-75A7-0FB0-DE8E-1CC0078DCF3E}"/>
              </a:ext>
            </a:extLst>
          </p:cNvPr>
          <p:cNvSpPr txBox="1"/>
          <p:nvPr/>
        </p:nvSpPr>
        <p:spPr>
          <a:xfrm>
            <a:off x="5410744" y="5763397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C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F21C5D37-2593-652A-2CEB-D28EA137EB69}"/>
              </a:ext>
            </a:extLst>
          </p:cNvPr>
          <p:cNvSpPr txBox="1"/>
          <p:nvPr/>
        </p:nvSpPr>
        <p:spPr>
          <a:xfrm>
            <a:off x="163502" y="3473"/>
            <a:ext cx="30382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 err="1"/>
              <a:t>Supplemental</a:t>
            </a:r>
            <a:r>
              <a:rPr lang="es-ES" sz="2400" b="1" dirty="0"/>
              <a:t> Figure 4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90556EFE-01D5-D07A-2D3B-25D7CAC1068F}"/>
              </a:ext>
            </a:extLst>
          </p:cNvPr>
          <p:cNvSpPr txBox="1"/>
          <p:nvPr/>
        </p:nvSpPr>
        <p:spPr>
          <a:xfrm>
            <a:off x="624782" y="7871791"/>
            <a:ext cx="11076888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4. Validation of splicing events induced by EIF4A3 silencing in HepG2 cells</a:t>
            </a:r>
            <a:r>
              <a:rPr lang="en-GB" sz="18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A-B) </a:t>
            </a:r>
            <a:r>
              <a:rPr lang="en-GB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 vitro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alysis and quantification of 19 of the 55 identified splicing events in siEIF4A3-treated HepG2 cells compared to scramble-treated cells. (C) Two different splicing events identified in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NAseq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data from </a:t>
            </a:r>
            <a:r>
              <a:rPr lang="en-GB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IF4A3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silenced HepG2 cells.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terisks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* p&lt;0,05)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indicate statistically significant differences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es-ES" sz="2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D56CA113-B0FD-49D8-1504-38F1F93A19B7}"/>
              </a:ext>
            </a:extLst>
          </p:cNvPr>
          <p:cNvSpPr txBox="1"/>
          <p:nvPr/>
        </p:nvSpPr>
        <p:spPr>
          <a:xfrm>
            <a:off x="10421781" y="6134809"/>
            <a:ext cx="1577137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s-ES_tradnl" sz="1000" b="1" noProof="1"/>
              <a:t>IncLevelDifference: -0,533</a:t>
            </a:r>
          </a:p>
          <a:p>
            <a:r>
              <a:rPr lang="es-ES_tradnl" sz="1000" b="1" noProof="1"/>
              <a:t>Pvalue: 0,029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B20AA0D1-6941-1516-1B2B-E9B292EAC1A4}"/>
              </a:ext>
            </a:extLst>
          </p:cNvPr>
          <p:cNvSpPr txBox="1"/>
          <p:nvPr/>
        </p:nvSpPr>
        <p:spPr>
          <a:xfrm>
            <a:off x="10421781" y="6804814"/>
            <a:ext cx="1577137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s-ES_tradnl" sz="1000" b="1" noProof="1"/>
              <a:t>IncLevelDifference: 0,024</a:t>
            </a:r>
          </a:p>
          <a:p>
            <a:r>
              <a:rPr lang="es-ES_tradnl" sz="1000" b="1" noProof="1"/>
              <a:t>Pvalue: 0,00004</a:t>
            </a:r>
          </a:p>
        </p:txBody>
      </p:sp>
    </p:spTree>
    <p:extLst>
      <p:ext uri="{BB962C8B-B14F-4D97-AF65-F5344CB8AC3E}">
        <p14:creationId xmlns:p14="http://schemas.microsoft.com/office/powerpoint/2010/main" val="5110262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ángulo 4">
            <a:extLst>
              <a:ext uri="{FF2B5EF4-FFF2-40B4-BE49-F238E27FC236}">
                <a16:creationId xmlns:a16="http://schemas.microsoft.com/office/drawing/2014/main" id="{5F760CC1-50DA-AF40-89B0-35C3442A9968}"/>
              </a:ext>
            </a:extLst>
          </p:cNvPr>
          <p:cNvSpPr/>
          <p:nvPr/>
        </p:nvSpPr>
        <p:spPr>
          <a:xfrm>
            <a:off x="6432929" y="1284253"/>
            <a:ext cx="234608" cy="3095742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s-ES" dirty="0">
                <a:solidFill>
                  <a:sysClr val="windowText" lastClr="000000"/>
                </a:solidFill>
              </a:rPr>
              <a:t>Hep3B</a:t>
            </a:r>
          </a:p>
        </p:txBody>
      </p:sp>
      <p:sp>
        <p:nvSpPr>
          <p:cNvPr id="7" name="Rectángulo 6">
            <a:extLst>
              <a:ext uri="{FF2B5EF4-FFF2-40B4-BE49-F238E27FC236}">
                <a16:creationId xmlns:a16="http://schemas.microsoft.com/office/drawing/2014/main" id="{DAFDC96B-566B-BE42-B991-A4839BF94023}"/>
              </a:ext>
            </a:extLst>
          </p:cNvPr>
          <p:cNvSpPr/>
          <p:nvPr/>
        </p:nvSpPr>
        <p:spPr>
          <a:xfrm>
            <a:off x="900758" y="1284252"/>
            <a:ext cx="234608" cy="3095742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s-ES" dirty="0">
                <a:solidFill>
                  <a:sysClr val="windowText" lastClr="000000"/>
                </a:solidFill>
              </a:rPr>
              <a:t>HepG2</a:t>
            </a:r>
          </a:p>
        </p:txBody>
      </p:sp>
      <p:pic>
        <p:nvPicPr>
          <p:cNvPr id="8" name="Imagen 7">
            <a:extLst>
              <a:ext uri="{FF2B5EF4-FFF2-40B4-BE49-F238E27FC236}">
                <a16:creationId xmlns:a16="http://schemas.microsoft.com/office/drawing/2014/main" id="{B7740F91-8626-E844-A0C1-86FD26D357C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5188" t="48967"/>
          <a:stretch/>
        </p:blipFill>
        <p:spPr>
          <a:xfrm>
            <a:off x="2334659" y="3897619"/>
            <a:ext cx="1306156" cy="1237238"/>
          </a:xfrm>
          <a:prstGeom prst="rect">
            <a:avLst/>
          </a:prstGeom>
        </p:spPr>
      </p:pic>
      <p:pic>
        <p:nvPicPr>
          <p:cNvPr id="9" name="Imagen 8">
            <a:extLst>
              <a:ext uri="{FF2B5EF4-FFF2-40B4-BE49-F238E27FC236}">
                <a16:creationId xmlns:a16="http://schemas.microsoft.com/office/drawing/2014/main" id="{7CF6467B-86B3-E241-B6FC-BB1D9612C4E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3615" t="48967"/>
          <a:stretch/>
        </p:blipFill>
        <p:spPr>
          <a:xfrm>
            <a:off x="8035295" y="3971761"/>
            <a:ext cx="1365173" cy="1237238"/>
          </a:xfrm>
          <a:prstGeom prst="rect">
            <a:avLst/>
          </a:prstGeom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id="{8B190690-22E2-B845-9956-493473B236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87981" y="1178244"/>
            <a:ext cx="2278202" cy="3249788"/>
          </a:xfrm>
          <a:prstGeom prst="rect">
            <a:avLst/>
          </a:prstGeom>
        </p:spPr>
      </p:pic>
      <p:pic>
        <p:nvPicPr>
          <p:cNvPr id="11" name="Imagen 10">
            <a:extLst>
              <a:ext uri="{FF2B5EF4-FFF2-40B4-BE49-F238E27FC236}">
                <a16:creationId xmlns:a16="http://schemas.microsoft.com/office/drawing/2014/main" id="{0D776FF6-512D-1549-A89E-DC98EF65207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27514" y="1185709"/>
            <a:ext cx="2277136" cy="3315242"/>
          </a:xfrm>
          <a:prstGeom prst="rect">
            <a:avLst/>
          </a:prstGeom>
        </p:spPr>
      </p:pic>
      <p:pic>
        <p:nvPicPr>
          <p:cNvPr id="12" name="Imagen 11">
            <a:extLst>
              <a:ext uri="{FF2B5EF4-FFF2-40B4-BE49-F238E27FC236}">
                <a16:creationId xmlns:a16="http://schemas.microsoft.com/office/drawing/2014/main" id="{4F434833-D628-4F4D-A2F0-5CD0DBDEB93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46976" y="1255267"/>
            <a:ext cx="2669722" cy="3095742"/>
          </a:xfrm>
          <a:prstGeom prst="rect">
            <a:avLst/>
          </a:prstGeom>
        </p:spPr>
      </p:pic>
      <p:pic>
        <p:nvPicPr>
          <p:cNvPr id="13" name="Imagen 12">
            <a:extLst>
              <a:ext uri="{FF2B5EF4-FFF2-40B4-BE49-F238E27FC236}">
                <a16:creationId xmlns:a16="http://schemas.microsoft.com/office/drawing/2014/main" id="{671D0947-6E82-A44F-B71A-44CCAAC001A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36975"/>
          <a:stretch/>
        </p:blipFill>
        <p:spPr>
          <a:xfrm>
            <a:off x="6685469" y="1346363"/>
            <a:ext cx="2594715" cy="3119804"/>
          </a:xfrm>
          <a:prstGeom prst="rect">
            <a:avLst/>
          </a:prstGeom>
        </p:spPr>
      </p:pic>
      <p:sp>
        <p:nvSpPr>
          <p:cNvPr id="19" name="CuadroTexto 18">
            <a:extLst>
              <a:ext uri="{FF2B5EF4-FFF2-40B4-BE49-F238E27FC236}">
                <a16:creationId xmlns:a16="http://schemas.microsoft.com/office/drawing/2014/main" id="{B6CC45BB-AE44-C44A-990F-46F8389EACA8}"/>
              </a:ext>
            </a:extLst>
          </p:cNvPr>
          <p:cNvSpPr txBox="1"/>
          <p:nvPr/>
        </p:nvSpPr>
        <p:spPr>
          <a:xfrm>
            <a:off x="637063" y="873217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A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31FF6838-971C-F240-A80D-11A83D42365E}"/>
              </a:ext>
            </a:extLst>
          </p:cNvPr>
          <p:cNvSpPr txBox="1"/>
          <p:nvPr/>
        </p:nvSpPr>
        <p:spPr>
          <a:xfrm>
            <a:off x="5991240" y="873217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B</a:t>
            </a:r>
          </a:p>
        </p:txBody>
      </p:sp>
      <p:pic>
        <p:nvPicPr>
          <p:cNvPr id="22" name="Imagen 21">
            <a:extLst>
              <a:ext uri="{FF2B5EF4-FFF2-40B4-BE49-F238E27FC236}">
                <a16:creationId xmlns:a16="http://schemas.microsoft.com/office/drawing/2014/main" id="{9E9CB855-DFCA-41F7-8244-E12F08BCEFAB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40475" t="92777"/>
          <a:stretch/>
        </p:blipFill>
        <p:spPr>
          <a:xfrm>
            <a:off x="1851150" y="666335"/>
            <a:ext cx="3473661" cy="256475"/>
          </a:xfrm>
          <a:prstGeom prst="rect">
            <a:avLst/>
          </a:prstGeom>
        </p:spPr>
      </p:pic>
      <p:pic>
        <p:nvPicPr>
          <p:cNvPr id="23" name="Imagen 22">
            <a:extLst>
              <a:ext uri="{FF2B5EF4-FFF2-40B4-BE49-F238E27FC236}">
                <a16:creationId xmlns:a16="http://schemas.microsoft.com/office/drawing/2014/main" id="{A26D4E5D-09E0-2B4D-89A8-358CF2871A9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40475" t="92777"/>
          <a:stretch/>
        </p:blipFill>
        <p:spPr>
          <a:xfrm>
            <a:off x="7015459" y="666335"/>
            <a:ext cx="3473661" cy="256475"/>
          </a:xfrm>
          <a:prstGeom prst="rect">
            <a:avLst/>
          </a:prstGeom>
        </p:spPr>
      </p:pic>
      <p:sp>
        <p:nvSpPr>
          <p:cNvPr id="21" name="CuadroTexto 20">
            <a:extLst>
              <a:ext uri="{FF2B5EF4-FFF2-40B4-BE49-F238E27FC236}">
                <a16:creationId xmlns:a16="http://schemas.microsoft.com/office/drawing/2014/main" id="{08D74C5D-8BD1-8F92-A237-211353AE6B9E}"/>
              </a:ext>
            </a:extLst>
          </p:cNvPr>
          <p:cNvSpPr txBox="1"/>
          <p:nvPr/>
        </p:nvSpPr>
        <p:spPr>
          <a:xfrm>
            <a:off x="163502" y="3473"/>
            <a:ext cx="30382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 err="1"/>
              <a:t>Supplemental</a:t>
            </a:r>
            <a:r>
              <a:rPr lang="es-ES" sz="2400" b="1" dirty="0"/>
              <a:t> Figure 5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F7638516-DBED-839E-8B33-F06CFB0D1133}"/>
              </a:ext>
            </a:extLst>
          </p:cNvPr>
          <p:cNvSpPr txBox="1"/>
          <p:nvPr/>
        </p:nvSpPr>
        <p:spPr>
          <a:xfrm>
            <a:off x="637063" y="5797207"/>
            <a:ext cx="10867587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5. Implication of EIF4A3 silencing in insulin </a:t>
            </a:r>
            <a:r>
              <a:rPr lang="en-GB" sz="18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ignaling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18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 vitro. 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Western-blot of downstream signalling of FGFR4 in HepG2 (A) and Hep3B (B) in response to </a:t>
            </a:r>
            <a:r>
              <a:rPr lang="en-GB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IF4A3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silencing and insulin (100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M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treatment. Data represent relative insulin-induced protein levels in siEIF4A3-treated vs scramble-treated cells. Relative protein level for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ERK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AKT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were normalized to total ERK and total AKT, respectively, and all protein level were normalized by Ponceau. Data are presented as mean ± SEM from n=3 independent experiments.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terisks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* p&lt;0,05)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indicate statistically significant differences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es-ES" sz="2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76836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718</TotalTime>
  <Words>777</Words>
  <Application>Microsoft Macintosh PowerPoint</Application>
  <PresentationFormat>Personalizado</PresentationFormat>
  <Paragraphs>51</Paragraphs>
  <Slides>5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NÁLISIS DE PRPF8 CON CORRELACIONES CLÍNICAS Y GRÁFICAS DE SUPERVIVENCIA Y RECURRENCIA EN COHORTES EN FRESCO Y EN PARAFINA</dc:title>
  <dc:creator>Helena Garcia Fernandez</dc:creator>
  <cp:lastModifiedBy>Manuel D. Gahete Ortiz</cp:lastModifiedBy>
  <cp:revision>610</cp:revision>
  <dcterms:created xsi:type="dcterms:W3CDTF">2019-11-23T14:27:06Z</dcterms:created>
  <dcterms:modified xsi:type="dcterms:W3CDTF">2022-09-29T11:37:49Z</dcterms:modified>
</cp:coreProperties>
</file>